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7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 varScale="1">
        <p:scale>
          <a:sx n="85" d="100"/>
          <a:sy n="85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460014-EC34-1548-9FB8-4F8B94B69AE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1113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8D058B1-C327-B661-235C-0CE0E6B2A74B}"/>
              </a:ext>
            </a:extLst>
          </p:cNvPr>
          <p:cNvSpPr txBox="1"/>
          <p:nvPr/>
        </p:nvSpPr>
        <p:spPr>
          <a:xfrm>
            <a:off x="0" y="0"/>
            <a:ext cx="2385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13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1DE5B519-FCF8-9A8F-2F58-92685DB1A674}"/>
              </a:ext>
            </a:extLst>
          </p:cNvPr>
          <p:cNvGrpSpPr/>
          <p:nvPr/>
        </p:nvGrpSpPr>
        <p:grpSpPr>
          <a:xfrm>
            <a:off x="8016" y="498824"/>
            <a:ext cx="3347008" cy="2283224"/>
            <a:chOff x="4644008" y="1102787"/>
            <a:chExt cx="4306745" cy="293792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180F7A4-F489-DC04-7552-EF3ED7DC974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644008" y="1102787"/>
              <a:ext cx="3672407" cy="2937926"/>
            </a:xfrm>
            <a:prstGeom prst="rect">
              <a:avLst/>
            </a:prstGeom>
          </p:spPr>
        </p:pic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998D177E-2330-D005-4941-48EE62CE8B1C}"/>
                </a:ext>
              </a:extLst>
            </p:cNvPr>
            <p:cNvSpPr/>
            <p:nvPr/>
          </p:nvSpPr>
          <p:spPr>
            <a:xfrm rot="1238571">
              <a:off x="5015020" y="2004889"/>
              <a:ext cx="648072" cy="936104"/>
            </a:xfrm>
            <a:prstGeom prst="ellipse">
              <a:avLst/>
            </a:prstGeom>
            <a:noFill/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I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47B37141-ABCA-EFE7-DFBB-2D8840B26A36}"/>
                </a:ext>
              </a:extLst>
            </p:cNvPr>
            <p:cNvSpPr/>
            <p:nvPr/>
          </p:nvSpPr>
          <p:spPr>
            <a:xfrm rot="4712951">
              <a:off x="5926281" y="2042893"/>
              <a:ext cx="648072" cy="1223834"/>
            </a:xfrm>
            <a:prstGeom prst="ellipse">
              <a:avLst/>
            </a:prstGeom>
            <a:noFill/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I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93DF4A2D-3B44-0EA5-07AE-169D31CB78A2}"/>
                </a:ext>
              </a:extLst>
            </p:cNvPr>
            <p:cNvSpPr/>
            <p:nvPr/>
          </p:nvSpPr>
          <p:spPr>
            <a:xfrm rot="19546411">
              <a:off x="6653327" y="1927649"/>
              <a:ext cx="522113" cy="472747"/>
            </a:xfrm>
            <a:prstGeom prst="ellipse">
              <a:avLst/>
            </a:prstGeom>
            <a:noFill/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I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1F7D6FD-0A54-E28F-E812-673D56825426}"/>
                </a:ext>
              </a:extLst>
            </p:cNvPr>
            <p:cNvSpPr txBox="1"/>
            <p:nvPr/>
          </p:nvSpPr>
          <p:spPr>
            <a:xfrm>
              <a:off x="7021949" y="1831254"/>
              <a:ext cx="821350" cy="257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700" b="1" dirty="0"/>
                <a:t>CD4+ T Cell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0AC3FDF-29C3-1103-2292-DA665E17C3B8}"/>
                </a:ext>
              </a:extLst>
            </p:cNvPr>
            <p:cNvSpPr txBox="1"/>
            <p:nvPr/>
          </p:nvSpPr>
          <p:spPr>
            <a:xfrm>
              <a:off x="6581259" y="2780161"/>
              <a:ext cx="821350" cy="257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700" b="1" dirty="0"/>
                <a:t>CD8+ T Cell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CCEF088-AE32-1E03-D555-A280EE963BF6}"/>
                </a:ext>
              </a:extLst>
            </p:cNvPr>
            <p:cNvSpPr txBox="1"/>
            <p:nvPr/>
          </p:nvSpPr>
          <p:spPr>
            <a:xfrm>
              <a:off x="4941931" y="2925151"/>
              <a:ext cx="627460" cy="257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700" b="1" dirty="0"/>
                <a:t>NK Cells</a:t>
              </a:r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63C62BBE-559B-21B5-C2F8-222347043F7A}"/>
                </a:ext>
              </a:extLst>
            </p:cNvPr>
            <p:cNvSpPr/>
            <p:nvPr/>
          </p:nvSpPr>
          <p:spPr>
            <a:xfrm>
              <a:off x="6448186" y="1694331"/>
              <a:ext cx="385890" cy="126557"/>
            </a:xfrm>
            <a:prstGeom prst="ellipse">
              <a:avLst/>
            </a:prstGeom>
            <a:noFill/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I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157994B-15C9-C5B2-71D1-74318B8D7456}"/>
                </a:ext>
              </a:extLst>
            </p:cNvPr>
            <p:cNvSpPr txBox="1"/>
            <p:nvPr/>
          </p:nvSpPr>
          <p:spPr>
            <a:xfrm>
              <a:off x="6514749" y="1503528"/>
              <a:ext cx="551141" cy="257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700" b="1" dirty="0"/>
                <a:t>B Cells</a:t>
              </a:r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9584CDC8-1935-389D-FB58-34CD12EB7EBB}"/>
                </a:ext>
              </a:extLst>
            </p:cNvPr>
            <p:cNvSpPr/>
            <p:nvPr/>
          </p:nvSpPr>
          <p:spPr>
            <a:xfrm rot="4917684">
              <a:off x="5907946" y="2760746"/>
              <a:ext cx="642350" cy="1398875"/>
            </a:xfrm>
            <a:prstGeom prst="ellipse">
              <a:avLst/>
            </a:prstGeom>
            <a:noFill/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I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ABADC97-FA49-19AA-EEA8-42FFBFD265C9}"/>
                </a:ext>
              </a:extLst>
            </p:cNvPr>
            <p:cNvSpPr txBox="1"/>
            <p:nvPr/>
          </p:nvSpPr>
          <p:spPr>
            <a:xfrm>
              <a:off x="6730165" y="3518102"/>
              <a:ext cx="1322574" cy="257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700" b="1" dirty="0"/>
                <a:t>Monocytes &amp; doublets</a:t>
              </a:r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1F72CF70-48B4-F74D-A344-374A4720A20F}"/>
                </a:ext>
              </a:extLst>
            </p:cNvPr>
            <p:cNvSpPr/>
            <p:nvPr/>
          </p:nvSpPr>
          <p:spPr>
            <a:xfrm rot="19546411">
              <a:off x="7473307" y="2313618"/>
              <a:ext cx="677591" cy="580138"/>
            </a:xfrm>
            <a:prstGeom prst="ellipse">
              <a:avLst/>
            </a:prstGeom>
            <a:noFill/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FI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F1AFC8E-1CFA-3D9C-0FB4-674B3B197527}"/>
                </a:ext>
              </a:extLst>
            </p:cNvPr>
            <p:cNvSpPr txBox="1"/>
            <p:nvPr/>
          </p:nvSpPr>
          <p:spPr>
            <a:xfrm>
              <a:off x="7919012" y="2780161"/>
              <a:ext cx="1031741" cy="2574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700" b="1" dirty="0"/>
                <a:t>Low quality cells</a:t>
              </a:r>
            </a:p>
          </p:txBody>
        </p:sp>
      </p:grpSp>
      <p:sp>
        <p:nvSpPr>
          <p:cNvPr id="33" name="Conector: curvado 7">
            <a:extLst>
              <a:ext uri="{FF2B5EF4-FFF2-40B4-BE49-F238E27FC236}">
                <a16:creationId xmlns:a16="http://schemas.microsoft.com/office/drawing/2014/main" id="{AD769C6C-B3F6-831E-C02C-49F76A3E1566}"/>
              </a:ext>
            </a:extLst>
          </p:cNvPr>
          <p:cNvSpPr/>
          <p:nvPr/>
        </p:nvSpPr>
        <p:spPr>
          <a:xfrm>
            <a:off x="847787" y="7341347"/>
            <a:ext cx="0" cy="0"/>
          </a:xfrm>
          <a:prstGeom prst="curvedConnector5">
            <a:avLst>
              <a:gd name="adj1" fmla="val -553521"/>
              <a:gd name="adj2" fmla="val 22533333"/>
              <a:gd name="adj3" fmla="val 1398592"/>
            </a:avLst>
          </a:prstGeom>
          <a:gradFill>
            <a:gsLst>
              <a:gs pos="1000">
                <a:srgbClr val="B4C0D6">
                  <a:alpha val="5000"/>
                </a:srgbClr>
              </a:gs>
              <a:gs pos="25000">
                <a:srgbClr val="DFECF9">
                  <a:alpha val="5000"/>
                </a:srgbClr>
              </a:gs>
              <a:gs pos="48000">
                <a:srgbClr val="B4C0D6">
                  <a:alpha val="5000"/>
                </a:srgbClr>
              </a:gs>
              <a:gs pos="69000">
                <a:srgbClr val="DFECF9">
                  <a:alpha val="5000"/>
                </a:srgbClr>
              </a:gs>
              <a:gs pos="86000">
                <a:srgbClr val="B4C0D6">
                  <a:alpha val="5000"/>
                </a:srgbClr>
              </a:gs>
              <a:gs pos="100000">
                <a:srgbClr val="DFECF9">
                  <a:alpha val="5000"/>
                </a:srgbClr>
              </a:gs>
            </a:gsLst>
          </a:gradFill>
          <a:ln w="9000">
            <a:gradFill>
              <a:gsLst>
                <a:gs pos="1000">
                  <a:srgbClr val="B4C0D6"/>
                </a:gs>
                <a:gs pos="25000">
                  <a:srgbClr val="DFECF9"/>
                </a:gs>
                <a:gs pos="48000">
                  <a:srgbClr val="B4C0D6"/>
                </a:gs>
                <a:gs pos="69000">
                  <a:srgbClr val="DFECF9"/>
                </a:gs>
                <a:gs pos="86000">
                  <a:srgbClr val="B4C0D6"/>
                </a:gs>
                <a:gs pos="100000">
                  <a:srgbClr val="DFECF9"/>
                </a:gs>
              </a:gsLst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wrap="none" rtlCol="0" anchor="ctr" anchorCtr="1"/>
          <a:lstStyle/>
          <a:p>
            <a:endParaRPr lang="en-US">
              <a:gradFill>
                <a:gsLst>
                  <a:gs pos="1000">
                    <a:srgbClr val="B4C0D6"/>
                  </a:gs>
                  <a:gs pos="25000">
                    <a:srgbClr val="DFECF9"/>
                  </a:gs>
                  <a:gs pos="48000">
                    <a:srgbClr val="B4C0D6"/>
                  </a:gs>
                  <a:gs pos="69000">
                    <a:srgbClr val="DFECF9"/>
                  </a:gs>
                  <a:gs pos="86000">
                    <a:srgbClr val="B4C0D6"/>
                  </a:gs>
                  <a:gs pos="100000">
                    <a:srgbClr val="DFECF9"/>
                  </a:gs>
                </a:gsLst>
              </a:gra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F985C79-E177-249C-9AC0-823F3D680A8A}"/>
              </a:ext>
            </a:extLst>
          </p:cNvPr>
          <p:cNvSpPr txBox="1"/>
          <p:nvPr/>
        </p:nvSpPr>
        <p:spPr>
          <a:xfrm>
            <a:off x="3306879" y="3693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A3380D7-B61F-4B5F-BCF1-7143D426B516}"/>
              </a:ext>
            </a:extLst>
          </p:cNvPr>
          <p:cNvSpPr txBox="1"/>
          <p:nvPr/>
        </p:nvSpPr>
        <p:spPr>
          <a:xfrm>
            <a:off x="0" y="282594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9EE86B50-D648-24D5-11F5-EF4B7DAC63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9377" y="5272790"/>
            <a:ext cx="4967548" cy="33116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E23205C-6E27-7775-032B-A25A2ADACC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4645" y="3195272"/>
            <a:ext cx="6858000" cy="1908819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3B21AFE8-C837-9AA6-412D-7009468E671B}"/>
              </a:ext>
            </a:extLst>
          </p:cNvPr>
          <p:cNvGrpSpPr/>
          <p:nvPr/>
        </p:nvGrpSpPr>
        <p:grpSpPr>
          <a:xfrm>
            <a:off x="3312236" y="931772"/>
            <a:ext cx="3478757" cy="1599600"/>
            <a:chOff x="-54070" y="1893150"/>
            <a:chExt cx="3693898" cy="1698526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84B2F8F-3B8D-34AD-EB69-A90B2DB0B5FA}"/>
                </a:ext>
              </a:extLst>
            </p:cNvPr>
            <p:cNvSpPr txBox="1"/>
            <p:nvPr/>
          </p:nvSpPr>
          <p:spPr>
            <a:xfrm>
              <a:off x="-54070" y="2187016"/>
              <a:ext cx="343151" cy="945485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prop of cells</a:t>
              </a:r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0ABAD028-D2DC-EA70-C0F0-4369E30B20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42776" y="1893150"/>
              <a:ext cx="3397052" cy="1698526"/>
            </a:xfrm>
            <a:prstGeom prst="rect">
              <a:avLst/>
            </a:prstGeom>
          </p:spPr>
        </p:pic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CC1E0EFA-B409-C087-5C80-2C4CF1FE03E3}"/>
              </a:ext>
            </a:extLst>
          </p:cNvPr>
          <p:cNvSpPr txBox="1"/>
          <p:nvPr/>
        </p:nvSpPr>
        <p:spPr>
          <a:xfrm>
            <a:off x="-1483" y="547078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3B92E3F-42DA-58A8-E5DC-D745B06D89DC}"/>
              </a:ext>
            </a:extLst>
          </p:cNvPr>
          <p:cNvSpPr txBox="1"/>
          <p:nvPr/>
        </p:nvSpPr>
        <p:spPr>
          <a:xfrm>
            <a:off x="-4645" y="8762791"/>
            <a:ext cx="6858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Bef>
                <a:spcPts val="300"/>
              </a:spcBef>
            </a:pP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13. </a:t>
            </a:r>
            <a:r>
              <a:rPr lang="en-US" sz="800" b="1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RNA</a:t>
            </a: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+ </a:t>
            </a:r>
            <a:r>
              <a:rPr lang="en-US" sz="800" b="1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CRab</a:t>
            </a:r>
            <a:r>
              <a:rPr lang="en-US" sz="8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seq data of tumor samples</a:t>
            </a:r>
            <a:endParaRPr lang="en-US" sz="8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itial UMAP from the lymphocyte enriched, CD45+ flow-sorted dissociated tumor samples (n=3) individually sequenced with paired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RNA+TCR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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seq. To focus on the T-cells, we removed 5 208 representing other cells of interest (B-cells, monocytes), 4 310 cells representing NK-cells, and low-quality cells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tacked </a:t>
            </a: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barplot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howing the proportion of expanded and single TCR clonotypes in each UMAP cluster of the T-cells from Fig. 6A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Dotplot</a:t>
            </a: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howing the top 10 differentially expressed genes (DEGs) associated with each cluster from the T-cell UMAP (Fig. 6A). 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8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aled expressions of the selected top marker DEGs from the T-cell UMAP (Fig. 6A).</a:t>
            </a:r>
            <a:endParaRPr lang="en-FI" sz="8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B122C7-FC0A-5F8C-2AEF-BCCE510C3A51}"/>
              </a:ext>
            </a:extLst>
          </p:cNvPr>
          <p:cNvSpPr txBox="1"/>
          <p:nvPr/>
        </p:nvSpPr>
        <p:spPr>
          <a:xfrm>
            <a:off x="0" y="3693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905122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84</TotalTime>
  <Words>164</Words>
  <Application>Microsoft Macintosh PowerPoint</Application>
  <PresentationFormat>A4-paperi (210 x 297 mm)</PresentationFormat>
  <Paragraphs>18</Paragraphs>
  <Slides>1</Slides>
  <Notes>1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6</cp:revision>
  <dcterms:created xsi:type="dcterms:W3CDTF">2022-10-13T13:05:53Z</dcterms:created>
  <dcterms:modified xsi:type="dcterms:W3CDTF">2023-06-17T07:38:10Z</dcterms:modified>
</cp:coreProperties>
</file>